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30915-4B7F-4BD7-99D0-04DB3831F3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A532B-9A63-43D3-A5F6-00B35955E6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585E74-A3C1-4141-9566-10CEFFF15D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BF888-46EC-4DC9-9452-7606DAE850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B4C9C-935D-428B-8BEE-1BC50675F5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7FAAD-D265-4705-A984-30C0EE81EC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EC536F-C32E-483F-9E7D-C7177DD3AE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29956C-FAEA-42BC-ADDA-3FA07EB684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15C93-353D-442F-80D8-1AEE5DD7D0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AC9B0-5AEE-4E1A-893E-7A821FE932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60587-87B4-45EF-9B1B-B28E42135E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B3C07-12F6-4437-8DEA-420ACB50CB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B499192-971F-4CFA-9ECE-1D0416189993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8621B3E-6718-4B54-9638-C2FE15C7DCA6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4" descr="ABC CD38 CD95 ouaga contrl vs Gender.jpg"/>
          <p:cNvPicPr/>
          <p:nvPr/>
        </p:nvPicPr>
        <p:blipFill>
          <a:blip r:embed="rId1"/>
          <a:stretch/>
        </p:blipFill>
        <p:spPr>
          <a:xfrm>
            <a:off x="388800" y="3716280"/>
            <a:ext cx="3895920" cy="2881440"/>
          </a:xfrm>
          <a:prstGeom prst="rect">
            <a:avLst/>
          </a:prstGeom>
          <a:ln w="0">
            <a:noFill/>
          </a:ln>
        </p:spPr>
      </p:pic>
      <p:pic>
        <p:nvPicPr>
          <p:cNvPr id="42" name="Grafik 5" descr="ABC CD95dim ouaga cntrl vs gender.jpg"/>
          <p:cNvPicPr/>
          <p:nvPr/>
        </p:nvPicPr>
        <p:blipFill>
          <a:blip r:embed="rId2"/>
          <a:stretch/>
        </p:blipFill>
        <p:spPr>
          <a:xfrm>
            <a:off x="5076720" y="3429000"/>
            <a:ext cx="3602160" cy="3240000"/>
          </a:xfrm>
          <a:prstGeom prst="rect">
            <a:avLst/>
          </a:prstGeom>
          <a:ln w="0">
            <a:noFill/>
          </a:ln>
        </p:spPr>
      </p:pic>
      <p:grpSp>
        <p:nvGrpSpPr>
          <p:cNvPr id="43" name="Gruppieren 11"/>
          <p:cNvGrpSpPr/>
          <p:nvPr/>
        </p:nvGrpSpPr>
        <p:grpSpPr>
          <a:xfrm>
            <a:off x="1692360" y="765000"/>
            <a:ext cx="2374920" cy="2950920"/>
            <a:chOff x="1692360" y="765000"/>
            <a:chExt cx="2374920" cy="2950920"/>
          </a:xfrm>
        </p:grpSpPr>
        <p:sp>
          <p:nvSpPr>
            <p:cNvPr id="44" name="Rechteck 9"/>
            <p:cNvSpPr/>
            <p:nvPr/>
          </p:nvSpPr>
          <p:spPr>
            <a:xfrm flipV="1">
              <a:off x="2195640" y="3283920"/>
              <a:ext cx="1152360" cy="43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hteck 10"/>
            <p:cNvSpPr/>
            <p:nvPr/>
          </p:nvSpPr>
          <p:spPr>
            <a:xfrm>
              <a:off x="1692360" y="765000"/>
              <a:ext cx="2374920" cy="3603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" name="Gruppieren 18"/>
          <p:cNvGrpSpPr/>
          <p:nvPr/>
        </p:nvGrpSpPr>
        <p:grpSpPr>
          <a:xfrm>
            <a:off x="755640" y="620640"/>
            <a:ext cx="3516480" cy="2992680"/>
            <a:chOff x="755640" y="620640"/>
            <a:chExt cx="3516480" cy="2992680"/>
          </a:xfrm>
        </p:grpSpPr>
        <p:pic>
          <p:nvPicPr>
            <p:cNvPr id="47" name="Grafik 16" descr="Bild4.png"/>
            <p:cNvPicPr/>
            <p:nvPr/>
          </p:nvPicPr>
          <p:blipFill>
            <a:blip r:embed="rId3"/>
            <a:stretch/>
          </p:blipFill>
          <p:spPr>
            <a:xfrm>
              <a:off x="755640" y="620640"/>
              <a:ext cx="3516480" cy="299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Textfeld 17"/>
            <p:cNvSpPr/>
            <p:nvPr/>
          </p:nvSpPr>
          <p:spPr>
            <a:xfrm>
              <a:off x="1131480" y="683280"/>
              <a:ext cx="3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Gruppieren 20"/>
          <p:cNvGrpSpPr/>
          <p:nvPr/>
        </p:nvGrpSpPr>
        <p:grpSpPr>
          <a:xfrm>
            <a:off x="4788000" y="620640"/>
            <a:ext cx="3922560" cy="2919600"/>
            <a:chOff x="4788000" y="620640"/>
            <a:chExt cx="3922560" cy="2919600"/>
          </a:xfrm>
        </p:grpSpPr>
        <p:pic>
          <p:nvPicPr>
            <p:cNvPr id="50" name="Grafik 3" descr="%CD38 CD95 ouaga control vs Gender.jpg"/>
            <p:cNvPicPr/>
            <p:nvPr/>
          </p:nvPicPr>
          <p:blipFill>
            <a:blip r:embed="rId4"/>
            <a:stretch/>
          </p:blipFill>
          <p:spPr>
            <a:xfrm>
              <a:off x="4788000" y="620640"/>
              <a:ext cx="3922560" cy="291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feld 19"/>
            <p:cNvSpPr/>
            <p:nvPr/>
          </p:nvSpPr>
          <p:spPr>
            <a:xfrm>
              <a:off x="5529240" y="692640"/>
              <a:ext cx="308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Textfeld 21"/>
          <p:cNvSpPr/>
          <p:nvPr/>
        </p:nvSpPr>
        <p:spPr>
          <a:xfrm>
            <a:off x="996480" y="378000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feld 22"/>
          <p:cNvSpPr/>
          <p:nvPr/>
        </p:nvSpPr>
        <p:spPr>
          <a:xfrm>
            <a:off x="5448960" y="370836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feld 21"/>
          <p:cNvSpPr/>
          <p:nvPr/>
        </p:nvSpPr>
        <p:spPr>
          <a:xfrm>
            <a:off x="3645720" y="6488280"/>
            <a:ext cx="212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F – female, M – ma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feld 5"/>
          <p:cNvSpPr/>
          <p:nvPr/>
        </p:nvSpPr>
        <p:spPr>
          <a:xfrm>
            <a:off x="324000" y="189000"/>
            <a:ext cx="7920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Supplementary material e. 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No gender-related differences in the percentage of naive and activated T cells or expression levels of T cell activation markers in healthy adults living in Ouagadougou (capital city of Burkina Faso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14T04:58:58Z</dcterms:created>
  <dc:creator>Tiba Fabrice</dc:creator>
  <dc:description/>
  <dc:language>en-US</dc:language>
  <cp:lastModifiedBy>LG</cp:lastModifiedBy>
  <dcterms:modified xsi:type="dcterms:W3CDTF">2011-11-04T16:41:21Z</dcterms:modified>
  <cp:revision>4</cp:revision>
  <dc:subject/>
  <dc:title>Folie 1</dc:title>
</cp:coreProperties>
</file>